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70" r:id="rId2"/>
    <p:sldId id="268" r:id="rId3"/>
    <p:sldId id="269" r:id="rId4"/>
    <p:sldId id="271" r:id="rId5"/>
  </p:sldIdLst>
  <p:sldSz cx="5143500" cy="91440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603" autoAdjust="0"/>
    <p:restoredTop sz="95244" autoAdjust="0"/>
  </p:normalViewPr>
  <p:slideViewPr>
    <p:cSldViewPr snapToGrid="0">
      <p:cViewPr>
        <p:scale>
          <a:sx n="300" d="100"/>
          <a:sy n="300" d="100"/>
        </p:scale>
        <p:origin x="-1142" y="-210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0BB760-1027-4BF3-BA55-93D2D9443987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0B7A9A-EF07-4D17-A27E-85D7FC143E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841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5763" y="1496484"/>
            <a:ext cx="4371975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2938" y="4802717"/>
            <a:ext cx="3857625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672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4049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80818" y="486834"/>
            <a:ext cx="1109067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3616" y="486834"/>
            <a:ext cx="3262908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1642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91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0937" y="2279653"/>
            <a:ext cx="4436269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0937" y="6119286"/>
            <a:ext cx="4436269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64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3615" y="2434167"/>
            <a:ext cx="2185988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3897" y="2434167"/>
            <a:ext cx="2185988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914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486836"/>
            <a:ext cx="4436269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4286" y="2241551"/>
            <a:ext cx="2175941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4286" y="3340100"/>
            <a:ext cx="2175941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03897" y="2241551"/>
            <a:ext cx="2186657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03897" y="3340100"/>
            <a:ext cx="2186657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762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9239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247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609600"/>
            <a:ext cx="165891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86657" y="1316569"/>
            <a:ext cx="2603897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4285" y="2743200"/>
            <a:ext cx="165891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787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609600"/>
            <a:ext cx="165891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86657" y="1316569"/>
            <a:ext cx="2603897" cy="6498167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4285" y="2743200"/>
            <a:ext cx="165891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8596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3616" y="486836"/>
            <a:ext cx="4436269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3616" y="2434167"/>
            <a:ext cx="4436269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3615" y="8475136"/>
            <a:ext cx="115728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48CDF-8364-410B-B950-2EB10BAA46BB}" type="datetimeFigureOut">
              <a:rPr lang="zh-CN" altLang="en-US" smtClean="0"/>
              <a:t>2021/7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03785" y="8475136"/>
            <a:ext cx="173593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32597" y="8475136"/>
            <a:ext cx="115728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2907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3667C7E-6B0E-407F-82C9-FD03D421B8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6872664"/>
              </p:ext>
            </p:extLst>
          </p:nvPr>
        </p:nvGraphicFramePr>
        <p:xfrm>
          <a:off x="869155" y="962724"/>
          <a:ext cx="2881314" cy="271868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59914">
                  <a:extLst>
                    <a:ext uri="{9D8B030D-6E8A-4147-A177-3AD203B41FA5}">
                      <a16:colId xmlns:a16="http://schemas.microsoft.com/office/drawing/2014/main" val="4096515615"/>
                    </a:ext>
                  </a:extLst>
                </a:gridCol>
                <a:gridCol w="750785">
                  <a:extLst>
                    <a:ext uri="{9D8B030D-6E8A-4147-A177-3AD203B41FA5}">
                      <a16:colId xmlns:a16="http://schemas.microsoft.com/office/drawing/2014/main" val="2906967208"/>
                    </a:ext>
                  </a:extLst>
                </a:gridCol>
                <a:gridCol w="1470615">
                  <a:extLst>
                    <a:ext uri="{9D8B030D-6E8A-4147-A177-3AD203B41FA5}">
                      <a16:colId xmlns:a16="http://schemas.microsoft.com/office/drawing/2014/main" val="3141027935"/>
                    </a:ext>
                  </a:extLst>
                </a:gridCol>
              </a:tblGrid>
              <a:tr h="291465">
                <a:tc grid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roup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0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VID-19</a:t>
                      </a:r>
                      <a:endParaRPr lang="zh-CN" altLang="en-US" sz="1000" dirty="0"/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8215488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Patients (n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dirty="0">
                          <a:effectLst/>
                        </a:rPr>
                        <a:t>78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2655414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rum samples (n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dirty="0">
                          <a:effectLst/>
                        </a:rPr>
                        <a:t>2,36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0715519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Ag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dirty="0">
                          <a:effectLst/>
                        </a:rPr>
                        <a:t>61.4±14.5 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2261822"/>
                  </a:ext>
                </a:extLst>
              </a:tr>
              <a:tr h="19812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Gende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l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8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093768089"/>
                  </a:ext>
                </a:extLst>
              </a:tr>
              <a:tr h="19240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emal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96</a:t>
                      </a:r>
                      <a:endParaRPr lang="en-US" altLang="zh-CN" sz="8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94014076"/>
                  </a:ext>
                </a:extLst>
              </a:tr>
              <a:tr h="198120"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verity/ outco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n-severe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69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0867038"/>
                  </a:ext>
                </a:extLst>
              </a:tr>
              <a:tr h="27241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vere 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9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8776784"/>
                  </a:ext>
                </a:extLst>
              </a:tr>
              <a:tr h="27241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ritical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5</a:t>
                      </a:r>
                      <a:endParaRPr lang="zh-CN" altLang="en-US" sz="8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9309611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rvivor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23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7164255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n-survivor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0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6633661"/>
                  </a:ext>
                </a:extLst>
              </a:tr>
              <a:tr h="320294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ource</a:t>
                      </a: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ongji Hospital, Wuhan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833097310"/>
                  </a:ext>
                </a:extLst>
              </a:tr>
            </a:tbl>
          </a:graphicData>
        </a:graphic>
      </p:graphicFrame>
      <p:sp>
        <p:nvSpPr>
          <p:cNvPr id="3" name="矩形 2">
            <a:extLst>
              <a:ext uri="{FF2B5EF4-FFF2-40B4-BE49-F238E27FC236}">
                <a16:creationId xmlns:a16="http://schemas.microsoft.com/office/drawing/2014/main" id="{78C52EAC-3E14-4198-A3C2-854E8A59EB93}"/>
              </a:ext>
            </a:extLst>
          </p:cNvPr>
          <p:cNvSpPr/>
          <p:nvPr/>
        </p:nvSpPr>
        <p:spPr>
          <a:xfrm>
            <a:off x="504824" y="591030"/>
            <a:ext cx="3609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/>
              <a:t>Table 1.  </a:t>
            </a:r>
            <a:r>
              <a:rPr lang="en-US" altLang="zh-CN" sz="1200" dirty="0"/>
              <a:t>The clinical information of patients involved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046482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3667C7E-6B0E-407F-82C9-FD03D421B834}"/>
              </a:ext>
            </a:extLst>
          </p:cNvPr>
          <p:cNvGraphicFramePr>
            <a:graphicFrameLocks noGrp="1"/>
          </p:cNvGraphicFramePr>
          <p:nvPr/>
        </p:nvGraphicFramePr>
        <p:xfrm>
          <a:off x="784110" y="888769"/>
          <a:ext cx="3259254" cy="2810107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780647">
                  <a:extLst>
                    <a:ext uri="{9D8B030D-6E8A-4147-A177-3AD203B41FA5}">
                      <a16:colId xmlns:a16="http://schemas.microsoft.com/office/drawing/2014/main" val="4096515615"/>
                    </a:ext>
                  </a:extLst>
                </a:gridCol>
                <a:gridCol w="950603">
                  <a:extLst>
                    <a:ext uri="{9D8B030D-6E8A-4147-A177-3AD203B41FA5}">
                      <a16:colId xmlns:a16="http://schemas.microsoft.com/office/drawing/2014/main" val="2906967208"/>
                    </a:ext>
                  </a:extLst>
                </a:gridCol>
                <a:gridCol w="1528004">
                  <a:extLst>
                    <a:ext uri="{9D8B030D-6E8A-4147-A177-3AD203B41FA5}">
                      <a16:colId xmlns:a16="http://schemas.microsoft.com/office/drawing/2014/main" val="3141027935"/>
                    </a:ext>
                  </a:extLst>
                </a:gridCol>
              </a:tblGrid>
              <a:tr h="29146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</a:rPr>
                        <a:t>Grou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</a:rPr>
                        <a:t>COVID-19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8215488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Patients (n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dirty="0">
                          <a:effectLst/>
                        </a:rPr>
                        <a:t>6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2655414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rum samples (n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92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0715519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g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9.6 ± 10.3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2261822"/>
                  </a:ext>
                </a:extLst>
              </a:tr>
              <a:tr h="19812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end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Mal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8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093768089"/>
                  </a:ext>
                </a:extLst>
              </a:tr>
              <a:tr h="19240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emal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2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94014076"/>
                  </a:ext>
                </a:extLst>
              </a:tr>
              <a:tr h="198120"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verity/ outco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non-sever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0867038"/>
                  </a:ext>
                </a:extLst>
              </a:tr>
              <a:tr h="27241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vere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8776784"/>
                  </a:ext>
                </a:extLst>
              </a:tr>
              <a:tr h="27241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</a:rPr>
                        <a:t>Criti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8</a:t>
                      </a:r>
                      <a:r>
                        <a:rPr lang="zh-CN" alt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　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9309611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rviv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7164255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dirty="0">
                          <a:effectLst/>
                        </a:rPr>
                        <a:t>Non-surviv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0</a:t>
                      </a: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6633661"/>
                  </a:ext>
                </a:extLst>
              </a:tr>
              <a:tr h="41171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our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ongji Hospital, Wuhan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833097310"/>
                  </a:ext>
                </a:extLst>
              </a:tr>
            </a:tbl>
          </a:graphicData>
        </a:graphic>
      </p:graphicFrame>
      <p:sp>
        <p:nvSpPr>
          <p:cNvPr id="3" name="矩形 2">
            <a:extLst>
              <a:ext uri="{FF2B5EF4-FFF2-40B4-BE49-F238E27FC236}">
                <a16:creationId xmlns:a16="http://schemas.microsoft.com/office/drawing/2014/main" id="{1202F174-DA7A-4E40-A799-CF7250033723}"/>
              </a:ext>
            </a:extLst>
          </p:cNvPr>
          <p:cNvSpPr/>
          <p:nvPr/>
        </p:nvSpPr>
        <p:spPr>
          <a:xfrm>
            <a:off x="685800" y="549961"/>
            <a:ext cx="42005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200" b="1" dirty="0"/>
              <a:t>Table 2.  </a:t>
            </a:r>
            <a:r>
              <a:rPr lang="en-US" altLang="zh-CN" sz="1200" dirty="0"/>
              <a:t>Serum sample of Cas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Ⅰ</a:t>
            </a:r>
            <a:endParaRPr lang="en-US" altLang="zh-CN" sz="1200" dirty="0"/>
          </a:p>
        </p:txBody>
      </p:sp>
    </p:spTree>
    <p:extLst>
      <p:ext uri="{BB962C8B-B14F-4D97-AF65-F5344CB8AC3E}">
        <p14:creationId xmlns:p14="http://schemas.microsoft.com/office/powerpoint/2010/main" val="3857131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38B4CA91-4EE3-4A07-A3C7-FC2B12198C0E}"/>
              </a:ext>
            </a:extLst>
          </p:cNvPr>
          <p:cNvGraphicFramePr>
            <a:graphicFrameLocks noGrp="1"/>
          </p:cNvGraphicFramePr>
          <p:nvPr/>
        </p:nvGraphicFramePr>
        <p:xfrm>
          <a:off x="826081" y="851442"/>
          <a:ext cx="3518907" cy="317128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816478">
                  <a:extLst>
                    <a:ext uri="{9D8B030D-6E8A-4147-A177-3AD203B41FA5}">
                      <a16:colId xmlns:a16="http://schemas.microsoft.com/office/drawing/2014/main" val="3154495761"/>
                    </a:ext>
                  </a:extLst>
                </a:gridCol>
                <a:gridCol w="591054">
                  <a:extLst>
                    <a:ext uri="{9D8B030D-6E8A-4147-A177-3AD203B41FA5}">
                      <a16:colId xmlns:a16="http://schemas.microsoft.com/office/drawing/2014/main" val="1260502183"/>
                    </a:ext>
                  </a:extLst>
                </a:gridCol>
                <a:gridCol w="1009127">
                  <a:extLst>
                    <a:ext uri="{9D8B030D-6E8A-4147-A177-3AD203B41FA5}">
                      <a16:colId xmlns:a16="http://schemas.microsoft.com/office/drawing/2014/main" val="781590092"/>
                    </a:ext>
                  </a:extLst>
                </a:gridCol>
                <a:gridCol w="1102248">
                  <a:extLst>
                    <a:ext uri="{9D8B030D-6E8A-4147-A177-3AD203B41FA5}">
                      <a16:colId xmlns:a16="http://schemas.microsoft.com/office/drawing/2014/main" val="3465826243"/>
                    </a:ext>
                  </a:extLst>
                </a:gridCol>
              </a:tblGrid>
              <a:tr h="29146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roup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roup 1</a:t>
                      </a:r>
                      <a:endParaRPr lang="zh-CN" altLang="en-US" sz="1000" b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roup 2</a:t>
                      </a:r>
                      <a:endParaRPr lang="zh-CN" altLang="en-US" sz="1000" b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2730061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Patients (n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31</a:t>
                      </a:r>
                    </a:p>
                  </a:txBody>
                  <a:tcPr marL="76200" marR="7620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83</a:t>
                      </a:r>
                    </a:p>
                  </a:txBody>
                  <a:tcPr marL="76200" marR="7620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6433743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rum samples (n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49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84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2635715"/>
                  </a:ext>
                </a:extLst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Ag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4.3 ± 12.4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8.1 ± 11.9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3840074"/>
                  </a:ext>
                </a:extLst>
              </a:tr>
              <a:tr h="19812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end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l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31</a:t>
                      </a:r>
                    </a:p>
                  </a:txBody>
                  <a:tcPr marL="76200" marR="76200" marT="60960" marB="6096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76200" marR="76200" marT="60960" marB="60960" anchor="ctr"/>
                </a:tc>
                <a:extLst>
                  <a:ext uri="{0D108BD9-81ED-4DB2-BD59-A6C34878D82A}">
                    <a16:rowId xmlns:a16="http://schemas.microsoft.com/office/drawing/2014/main" val="2314436505"/>
                  </a:ext>
                </a:extLst>
              </a:tr>
              <a:tr h="19240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Femal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76200" marR="76200" marT="60960" marB="6096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83</a:t>
                      </a:r>
                    </a:p>
                  </a:txBody>
                  <a:tcPr marL="76200" marR="76200" marT="60960" marB="60960" anchor="ctr"/>
                </a:tc>
                <a:extLst>
                  <a:ext uri="{0D108BD9-81ED-4DB2-BD59-A6C34878D82A}">
                    <a16:rowId xmlns:a16="http://schemas.microsoft.com/office/drawing/2014/main" val="3146556602"/>
                  </a:ext>
                </a:extLst>
              </a:tr>
              <a:tr h="198120"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verity/ outco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non-sever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402667"/>
                  </a:ext>
                </a:extLst>
              </a:tr>
              <a:tr h="27241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evere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65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44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3088501"/>
                  </a:ext>
                </a:extLst>
              </a:tr>
              <a:tr h="27241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Critic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6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9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5444931"/>
                  </a:ext>
                </a:extLst>
              </a:tr>
              <a:tr h="25812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rvivor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93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61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1333359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Dea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8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2</a:t>
                      </a:r>
                    </a:p>
                  </a:txBody>
                  <a:tcPr marL="76200" marR="76200" marT="60960" marB="6096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0429348"/>
                  </a:ext>
                </a:extLst>
              </a:tr>
              <a:tr h="36998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our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Tongji Hospital, Wuh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u="none" strike="noStrike" dirty="0">
                          <a:effectLst/>
                        </a:rPr>
                        <a:t>Tongji Hospital, Wuha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 Regular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516566606"/>
                  </a:ext>
                </a:extLst>
              </a:tr>
            </a:tbl>
          </a:graphicData>
        </a:graphic>
      </p:graphicFrame>
      <p:sp>
        <p:nvSpPr>
          <p:cNvPr id="3" name="矩形 2">
            <a:extLst>
              <a:ext uri="{FF2B5EF4-FFF2-40B4-BE49-F238E27FC236}">
                <a16:creationId xmlns:a16="http://schemas.microsoft.com/office/drawing/2014/main" id="{14EC4DB5-B801-4EDC-811D-BB1285AFF861}"/>
              </a:ext>
            </a:extLst>
          </p:cNvPr>
          <p:cNvSpPr/>
          <p:nvPr/>
        </p:nvSpPr>
        <p:spPr>
          <a:xfrm>
            <a:off x="703262" y="505510"/>
            <a:ext cx="36417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/>
              <a:t>Table 3.  </a:t>
            </a:r>
            <a:r>
              <a:rPr lang="en-US" altLang="zh-CN" sz="1200" dirty="0"/>
              <a:t>Serum sample of Cas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Ⅱ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3974349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690A963B-8064-49BC-9B02-353CD9A9D108}"/>
              </a:ext>
            </a:extLst>
          </p:cNvPr>
          <p:cNvGraphicFramePr>
            <a:graphicFrameLocks noGrp="1"/>
          </p:cNvGraphicFramePr>
          <p:nvPr/>
        </p:nvGraphicFramePr>
        <p:xfrm>
          <a:off x="715736" y="1345208"/>
          <a:ext cx="3712027" cy="85725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423905">
                  <a:extLst>
                    <a:ext uri="{9D8B030D-6E8A-4147-A177-3AD203B41FA5}">
                      <a16:colId xmlns:a16="http://schemas.microsoft.com/office/drawing/2014/main" val="1752437076"/>
                    </a:ext>
                  </a:extLst>
                </a:gridCol>
                <a:gridCol w="525874">
                  <a:extLst>
                    <a:ext uri="{9D8B030D-6E8A-4147-A177-3AD203B41FA5}">
                      <a16:colId xmlns:a16="http://schemas.microsoft.com/office/drawing/2014/main" val="2248597169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1515213917"/>
                    </a:ext>
                  </a:extLst>
                </a:gridCol>
                <a:gridCol w="558800">
                  <a:extLst>
                    <a:ext uri="{9D8B030D-6E8A-4147-A177-3AD203B41FA5}">
                      <a16:colId xmlns:a16="http://schemas.microsoft.com/office/drawing/2014/main" val="2639130631"/>
                    </a:ext>
                  </a:extLst>
                </a:gridCol>
                <a:gridCol w="1187450">
                  <a:extLst>
                    <a:ext uri="{9D8B030D-6E8A-4147-A177-3AD203B41FA5}">
                      <a16:colId xmlns:a16="http://schemas.microsoft.com/office/drawing/2014/main" val="1016192225"/>
                    </a:ext>
                  </a:extLst>
                </a:gridCol>
                <a:gridCol w="482598">
                  <a:extLst>
                    <a:ext uri="{9D8B030D-6E8A-4147-A177-3AD203B41FA5}">
                      <a16:colId xmlns:a16="http://schemas.microsoft.com/office/drawing/2014/main" val="3140726982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/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en-US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verity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00249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l-GR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β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E.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ald c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R (95% CI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54709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kern="1200" dirty="0">
                        <a:solidFill>
                          <a:srgbClr val="000000"/>
                        </a:solidFill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kern="1200">
                        <a:solidFill>
                          <a:srgbClr val="000000"/>
                        </a:solidFill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kern="1200">
                        <a:solidFill>
                          <a:srgbClr val="000000"/>
                        </a:solidFill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kern="1200" dirty="0">
                        <a:solidFill>
                          <a:srgbClr val="000000"/>
                        </a:solidFill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3593194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4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.1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1.724 (1.298, 2.288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2463042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1A618804-3CAE-440F-B9EA-55A90507C808}"/>
              </a:ext>
            </a:extLst>
          </p:cNvPr>
          <p:cNvSpPr txBox="1"/>
          <p:nvPr/>
        </p:nvSpPr>
        <p:spPr>
          <a:xfrm>
            <a:off x="320071" y="914321"/>
            <a:ext cx="45033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/>
              <a:t>Table 4. </a:t>
            </a:r>
            <a:r>
              <a:rPr lang="en-US" altLang="zh-CN" sz="1100" dirty="0"/>
              <a:t>The binary logistic regression parameter of severity in association with the gender among diagnosed COVID-19 patients 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4059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60</TotalTime>
  <Words>211</Words>
  <Application>Microsoft Office PowerPoint</Application>
  <PresentationFormat>全屏显示(16:9)</PresentationFormat>
  <Paragraphs>11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1" baseType="lpstr">
      <vt:lpstr>Arial Regular</vt:lpstr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ZW</dc:creator>
  <cp:lastModifiedBy>XZW</cp:lastModifiedBy>
  <cp:revision>120</cp:revision>
  <dcterms:created xsi:type="dcterms:W3CDTF">2020-09-25T01:15:47Z</dcterms:created>
  <dcterms:modified xsi:type="dcterms:W3CDTF">2021-07-24T00:56:47Z</dcterms:modified>
</cp:coreProperties>
</file>